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95" autoAdjust="0"/>
    <p:restoredTop sz="94660"/>
  </p:normalViewPr>
  <p:slideViewPr>
    <p:cSldViewPr snapToGrid="0">
      <p:cViewPr>
        <p:scale>
          <a:sx n="75" d="100"/>
          <a:sy n="75" d="100"/>
        </p:scale>
        <p:origin x="180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141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92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035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22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365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07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8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52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171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682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345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90C48-0C3D-4C49-89B3-027FB4F35D77}" type="datetimeFigureOut">
              <a:rPr lang="zh-CN" altLang="en-US" smtClean="0"/>
              <a:t>2024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0641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04766" y="6255491"/>
            <a:ext cx="515948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viruses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reported to infect chrysanthemums are not identified using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T-PCR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(35 cycles). M, mark; N, ddH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; H, healthy virus-free seedling in tissue culture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he primers are listed in Table S5. Cucumber mosaic virus (CMV),Tomato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aspermy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virus (TAV),Potato virus X (PVX),Potato virus Y (PVY),Sweet potato feather mottle virus (SPFMV),Tobacco mosaic virus (TMV),Tomato spotted wilt virus (TSWV),Zucchini yellow mosaic virus (ZYMV),Chrysanthemum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hlorotic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mottle viroid (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ChMVd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),Chrysanthemum stunt viroid (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SVd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804627" y="359547"/>
            <a:ext cx="2157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  H   N       VIH         RVFH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4580295" y="612138"/>
            <a:ext cx="60609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5289947" y="612138"/>
            <a:ext cx="67210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552334" y="1121894"/>
            <a:ext cx="4369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bp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50678" y="1213596"/>
            <a:ext cx="4369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0bp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54" t="36035" r="30207" b="46830"/>
          <a:stretch/>
        </p:blipFill>
        <p:spPr>
          <a:xfrm>
            <a:off x="3842180" y="648473"/>
            <a:ext cx="2160000" cy="90495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4" t="36035" r="59615" b="48012"/>
          <a:stretch/>
        </p:blipFill>
        <p:spPr>
          <a:xfrm>
            <a:off x="904767" y="652745"/>
            <a:ext cx="2160000" cy="900683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3" t="59178" r="59138" b="22089"/>
          <a:stretch/>
        </p:blipFill>
        <p:spPr>
          <a:xfrm>
            <a:off x="904767" y="1620245"/>
            <a:ext cx="2160000" cy="104125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09" t="58845" r="29056" b="22089"/>
          <a:stretch/>
        </p:blipFill>
        <p:spPr>
          <a:xfrm>
            <a:off x="3842180" y="1609278"/>
            <a:ext cx="2160000" cy="1059217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3019049" y="1014214"/>
            <a:ext cx="6208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M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962057" y="1035080"/>
            <a:ext cx="6208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A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026802" y="2066268"/>
            <a:ext cx="6208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VX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962056" y="1970190"/>
            <a:ext cx="6208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VY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997568" y="3118323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PFM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36" t="25092" r="44003" b="52335"/>
          <a:stretch/>
        </p:blipFill>
        <p:spPr>
          <a:xfrm>
            <a:off x="904767" y="2728312"/>
            <a:ext cx="2160000" cy="1102817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3" t="31469" r="70240" b="54292"/>
          <a:stretch/>
        </p:blipFill>
        <p:spPr>
          <a:xfrm>
            <a:off x="3842180" y="4999098"/>
            <a:ext cx="2160000" cy="105059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85" t="54826" r="69013" b="31475"/>
          <a:stretch/>
        </p:blipFill>
        <p:spPr>
          <a:xfrm>
            <a:off x="904766" y="5103410"/>
            <a:ext cx="2160000" cy="990031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3011844" y="5367056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SV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5962054" y="5331049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ChMV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33" t="59029" r="63469" b="24506"/>
          <a:stretch/>
        </p:blipFill>
        <p:spPr>
          <a:xfrm>
            <a:off x="3842181" y="2722987"/>
            <a:ext cx="2160000" cy="1114785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5962056" y="3141561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M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2" t="37906" r="64018" b="47894"/>
          <a:stretch/>
        </p:blipFill>
        <p:spPr>
          <a:xfrm>
            <a:off x="904766" y="3962446"/>
            <a:ext cx="2160000" cy="978914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07" t="60897" r="58829" b="22194"/>
          <a:stretch/>
        </p:blipFill>
        <p:spPr>
          <a:xfrm>
            <a:off x="3842180" y="3972934"/>
            <a:ext cx="2160000" cy="914779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>
            <a:off x="5962055" y="4344269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ZYM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25"/>
          <p:cNvSpPr txBox="1"/>
          <p:nvPr/>
        </p:nvSpPr>
        <p:spPr>
          <a:xfrm>
            <a:off x="3011845" y="4301182"/>
            <a:ext cx="8070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SWV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955029" y="359547"/>
            <a:ext cx="2157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  H   N      VIH          RVFH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>
            <a:off x="1723747" y="612349"/>
            <a:ext cx="60609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2452114" y="612138"/>
            <a:ext cx="5454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2227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4" t="1514" r="1341" b="6535"/>
          <a:stretch/>
        </p:blipFill>
        <p:spPr>
          <a:xfrm>
            <a:off x="795020" y="1221740"/>
            <a:ext cx="5032526" cy="3600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895515" y="5235271"/>
            <a:ext cx="516069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EGs levels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in ‘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Sphingolipid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’ KEGG pathway. Red indicated </a:t>
            </a:r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genes and green indicated </a:t>
            </a:r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wnregualted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genes. </a:t>
            </a:r>
            <a:endParaRPr lang="en-US" altLang="zh-CN" sz="1100" dirty="0" smtClean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4263162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814363" y="5329250"/>
            <a:ext cx="451963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S3. The gene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levels were verified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T-</a:t>
            </a:r>
            <a:r>
              <a:rPr lang="en-US" altLang="zh-CN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Values are the mean ±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D (n = 3).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n.d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, no detection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rimers are listed in Table S5.</a:t>
            </a:r>
            <a:endParaRPr lang="en-US" altLang="zh-CN" sz="1100" dirty="0" smtClean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1067049" y="2025523"/>
            <a:ext cx="4431801" cy="3172484"/>
            <a:chOff x="1067049" y="2025523"/>
            <a:chExt cx="4431801" cy="3172484"/>
          </a:xfrm>
        </p:grpSpPr>
        <p:cxnSp>
          <p:nvCxnSpPr>
            <p:cNvPr id="5" name="直接连接符 4"/>
            <p:cNvCxnSpPr/>
            <p:nvPr/>
          </p:nvCxnSpPr>
          <p:spPr>
            <a:xfrm>
              <a:off x="1117600" y="4907502"/>
              <a:ext cx="92202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" name="文本框 5"/>
            <p:cNvSpPr txBox="1"/>
            <p:nvPr/>
          </p:nvSpPr>
          <p:spPr>
            <a:xfrm>
              <a:off x="1294130" y="4890230"/>
              <a:ext cx="701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CS</a:t>
              </a:r>
              <a:endParaRPr lang="zh-CN" alt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630170" y="4890230"/>
              <a:ext cx="701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L</a:t>
              </a:r>
              <a:endParaRPr lang="zh-CN" alt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/>
            <p:cNvCxnSpPr/>
            <p:nvPr/>
          </p:nvCxnSpPr>
          <p:spPr>
            <a:xfrm>
              <a:off x="2169160" y="4907502"/>
              <a:ext cx="160274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7049" y="2025523"/>
              <a:ext cx="4431801" cy="281635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4250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3</TotalTime>
  <Words>191</Words>
  <Application>Microsoft Office PowerPoint</Application>
  <PresentationFormat>A4 纸张(210x297 毫米)</PresentationFormat>
  <Paragraphs>1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Company>Mico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xjdu</cp:lastModifiedBy>
  <cp:revision>38</cp:revision>
  <dcterms:created xsi:type="dcterms:W3CDTF">2021-04-02T07:19:11Z</dcterms:created>
  <dcterms:modified xsi:type="dcterms:W3CDTF">2024-02-26T15:35:40Z</dcterms:modified>
</cp:coreProperties>
</file>